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1836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5/05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5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5/2020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5/2020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5/2020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5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5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5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Jennings et al (2020) Diabetologia DOI 10.1007/s00125-020-05161-0 </a:t>
            </a:r>
          </a:p>
          <a:p>
            <a:r>
              <a:rPr lang="en-GB" sz="1200" dirty="0"/>
              <a:t>©The Authors 2020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Developmental classification of permanent neonatal diabetes</a:t>
            </a:r>
            <a:endParaRPr lang="en-GB" sz="20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E36D861-6C10-4624-AE53-C440D7ECB47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43608" y="732552"/>
            <a:ext cx="7128792" cy="51559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3</TotalTime>
  <Words>47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Shelley Williams</cp:lastModifiedBy>
  <cp:revision>34</cp:revision>
  <dcterms:created xsi:type="dcterms:W3CDTF">2016-06-15T12:53:43Z</dcterms:created>
  <dcterms:modified xsi:type="dcterms:W3CDTF">2020-05-05T17:30:09Z</dcterms:modified>
</cp:coreProperties>
</file>